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5" r:id="rId2"/>
    <p:sldId id="275" r:id="rId3"/>
    <p:sldId id="27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84" y="1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C6ED92-D61F-4160-9558-515E076EA9CA}" type="datetimeFigureOut">
              <a:rPr lang="en-IN" smtClean="0"/>
              <a:t>14-02-2022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73ABC2-C6EC-411B-BD51-4EBF1F53428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316214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E9FFB2-2E59-40C5-A575-42ECD6F776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8E96D87-E0DE-4ED6-A71F-DE23F4E7D52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549BFB-0AC5-4938-B890-E3E8BF9FB9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D0502-4FEE-4CBB-9AA6-BB4009C8E064}" type="datetimeFigureOut">
              <a:rPr lang="en-IN" smtClean="0"/>
              <a:t>14-02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54D53E-9F0C-486C-80C5-2598E2B16A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D63ECE-67E2-4A62-B443-3944E7DC01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41F87-4A93-452C-B5C6-35A506EC34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213526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F620A6-6C69-4F7E-9B35-61A3D623E7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99EE91F-24E4-4104-A59A-E65F1D0B28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EAFAEB-969D-4B07-8AF9-FB12764D1B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D0502-4FEE-4CBB-9AA6-BB4009C8E064}" type="datetimeFigureOut">
              <a:rPr lang="en-IN" smtClean="0"/>
              <a:t>14-02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518185-E6BF-4563-99D5-E38BF0D302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0F9667-E08B-4A67-AFD3-68FF37208F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41F87-4A93-452C-B5C6-35A506EC34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104704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3BCADB4-BC78-4826-A2CE-8F94BBFFBAB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2F2591A-8865-4A8E-A11F-0F034E6157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78966B-C848-4161-8E58-C72083F2EC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D0502-4FEE-4CBB-9AA6-BB4009C8E064}" type="datetimeFigureOut">
              <a:rPr lang="en-IN" smtClean="0"/>
              <a:t>14-02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FD8EDF-1A0B-489C-89A4-BDE9EFB47D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4DA97F-9AA6-45F3-A82D-F1B5A0C52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41F87-4A93-452C-B5C6-35A506EC34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50329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9503B3-7A35-4622-B0B3-5009C3C479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4CC647-B734-4231-A622-2A1C1F94C7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936B62-8E3C-45A2-B75D-D15C014257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D0502-4FEE-4CBB-9AA6-BB4009C8E064}" type="datetimeFigureOut">
              <a:rPr lang="en-IN" smtClean="0"/>
              <a:t>14-02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EEA0FF-968E-48DF-8287-7F00B01FEF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583DA4-64D0-4B28-BBAF-96CE02FEE0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41F87-4A93-452C-B5C6-35A506EC34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928090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CA89F8-9071-4B3F-99EF-8E8C605642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9F8F23-8CF4-4033-8719-1CF82CCA3E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A51D6A-072D-4205-A190-01B0A31F56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D0502-4FEE-4CBB-9AA6-BB4009C8E064}" type="datetimeFigureOut">
              <a:rPr lang="en-IN" smtClean="0"/>
              <a:t>14-02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325768-597F-48E5-8818-F022CE7BD1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A782FA-CA12-4CE6-9FFF-AD611BF724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41F87-4A93-452C-B5C6-35A506EC34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50535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194074-9F32-4462-8D75-9F28F7E120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AA61DB-8C3D-44DD-A3FE-137D7A940F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57755E-09E7-4831-B3B1-C455D95CAC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0496A7-9B7C-4DDB-A1C0-A53375B097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D0502-4FEE-4CBB-9AA6-BB4009C8E064}" type="datetimeFigureOut">
              <a:rPr lang="en-IN" smtClean="0"/>
              <a:t>14-02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BEDEF9-611D-4B97-8E55-1394BC7ED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455A23-A088-4FCC-B827-A67E3747D5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41F87-4A93-452C-B5C6-35A506EC34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265647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0F3B0F-C7CE-4813-B6EE-17DFD38B2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2A9649-9BDA-4196-A3DC-59D300A457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1C615A-0069-436E-B2E2-C38A9B493E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CC18BC3-CB68-4C22-9C34-1FFECCE2A33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83A48D5-4D1B-4673-8C15-59BA4B1E00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94701CC-BD2A-4E5E-A6D6-76D069553C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D0502-4FEE-4CBB-9AA6-BB4009C8E064}" type="datetimeFigureOut">
              <a:rPr lang="en-IN" smtClean="0"/>
              <a:t>14-02-2022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8BB6672-6600-41BB-93F2-28D8E45051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C154CB2-D9FD-49C1-A263-B6BD2C8986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41F87-4A93-452C-B5C6-35A506EC34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97571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2744FB-2ECF-4DE8-9ACD-FD0A25E893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96BB4EC-E31F-488A-816C-0DA21252F8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D0502-4FEE-4CBB-9AA6-BB4009C8E064}" type="datetimeFigureOut">
              <a:rPr lang="en-IN" smtClean="0"/>
              <a:t>14-02-2022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AAE9624-C33E-4F75-9BF4-2D180C82E3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2C480C4-2F49-4720-8B30-5BBE4907F4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41F87-4A93-452C-B5C6-35A506EC34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060679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0F20075-4633-4891-A364-0F1E713816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D0502-4FEE-4CBB-9AA6-BB4009C8E064}" type="datetimeFigureOut">
              <a:rPr lang="en-IN" smtClean="0"/>
              <a:t>14-02-2022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8C0BCA0-A495-4CA1-B924-2F58F04DB1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37E12B6-9A8F-49E4-9B09-050F046A7F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41F87-4A93-452C-B5C6-35A506EC34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58586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5C69D5-025F-4D36-AE8D-276EBE05CE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3B509C-A909-4D26-AE03-414F142303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15D3AC1-5017-4B13-B6CF-6E0265A38A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BA177E-6BDC-4DDD-9FF8-1E10B0C74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D0502-4FEE-4CBB-9AA6-BB4009C8E064}" type="datetimeFigureOut">
              <a:rPr lang="en-IN" smtClean="0"/>
              <a:t>14-02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388B5A-5C76-4F06-95EF-82570D4AC8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9CED2A-6F63-4814-84E7-71E7952227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41F87-4A93-452C-B5C6-35A506EC34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015338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0FAC30-5875-4D0D-9381-7DBDE765A1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855F01C-6488-4D04-9CF1-901F4ADB3F3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83262D-88AB-4BA7-9F82-C5000EDC3F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5877AC-99FE-40CE-8890-D6F07C68F9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D0502-4FEE-4CBB-9AA6-BB4009C8E064}" type="datetimeFigureOut">
              <a:rPr lang="en-IN" smtClean="0"/>
              <a:t>14-02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98285B-7C50-46C0-B76A-BDD63D3BEF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5A25D2-3E91-4431-8739-66E20FFFC4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41F87-4A93-452C-B5C6-35A506EC34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21415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D78DF67-BED1-40F8-9E3A-79CAAF5CDA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0B1CBD-F08D-4727-A03E-E57C06AE76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90A7B1-53B9-4554-8A15-520701A6858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2D0502-4FEE-4CBB-9AA6-BB4009C8E064}" type="datetimeFigureOut">
              <a:rPr lang="en-IN" smtClean="0"/>
              <a:t>14-02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0EDDF0-C35A-4761-9E79-E21E2B1AD2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52DFEA-C22D-412C-AD17-40B871B35A6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C41F87-4A93-452C-B5C6-35A506EC34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747865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7403F73-875B-41BB-BDEE-E489E42FEFB0}"/>
              </a:ext>
            </a:extLst>
          </p:cNvPr>
          <p:cNvSpPr txBox="1"/>
          <p:nvPr/>
        </p:nvSpPr>
        <p:spPr>
          <a:xfrm>
            <a:off x="2412130" y="6046076"/>
            <a:ext cx="796722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representation of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RILs development, phenotyping for disease severity in multi environments, and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ulked segregant RNA-Seq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SR-Seq) to identify SNPs for the spot blotch resistance.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SA, bulk segregant analysis; QC, quality </a:t>
            </a:r>
            <a:r>
              <a:rPr lang="en-IN" sz="12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BFR, bulk </a:t>
            </a:r>
            <a:r>
              <a:rPr lang="en-IN" sz="1200">
                <a:latin typeface="Times New Roman" panose="02020603050405020304" pitchFamily="18" charset="0"/>
                <a:cs typeface="Times New Roman" panose="02020603050405020304" pitchFamily="18" charset="0"/>
              </a:rPr>
              <a:t>frequency ratio.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528B2D1-781D-4C03-A45E-3EA6C3F7190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5763" t="22876" r="13316" b="11439"/>
          <a:stretch/>
        </p:blipFill>
        <p:spPr>
          <a:xfrm>
            <a:off x="2380755" y="83450"/>
            <a:ext cx="7998594" cy="58036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51173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EE4C8B5-5DAC-421A-8081-ABAF719B90F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0970" t="6207" r="17578" b="33908"/>
          <a:stretch/>
        </p:blipFill>
        <p:spPr>
          <a:xfrm>
            <a:off x="2486889" y="402019"/>
            <a:ext cx="7368710" cy="482425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589AD13-57C4-44E8-BCEF-A9588157FB20}"/>
              </a:ext>
            </a:extLst>
          </p:cNvPr>
          <p:cNvSpPr txBox="1"/>
          <p:nvPr/>
        </p:nvSpPr>
        <p:spPr>
          <a:xfrm>
            <a:off x="2766862" y="5281448"/>
            <a:ext cx="6787045" cy="755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Figure S2 </a:t>
            </a:r>
            <a:r>
              <a: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lang="en-US" sz="12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Significant GO classifications associated with transcripts containing polymorphic SNPs for SB resistance</a:t>
            </a:r>
            <a:endParaRPr lang="en-IN" sz="1200" dirty="0"/>
          </a:p>
        </p:txBody>
      </p:sp>
    </p:spTree>
    <p:extLst>
      <p:ext uri="{BB962C8B-B14F-4D97-AF65-F5344CB8AC3E}">
        <p14:creationId xmlns:p14="http://schemas.microsoft.com/office/powerpoint/2010/main" val="32222466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850A110-6C84-460D-881C-1A69E5208AF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8728" t="12644" r="17823" b="39195"/>
          <a:stretch/>
        </p:blipFill>
        <p:spPr>
          <a:xfrm>
            <a:off x="2774736" y="512378"/>
            <a:ext cx="6992773" cy="436007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8DE0A44-BB71-4579-AA9C-8FBD96828830}"/>
              </a:ext>
            </a:extLst>
          </p:cNvPr>
          <p:cNvSpPr txBox="1"/>
          <p:nvPr/>
        </p:nvSpPr>
        <p:spPr>
          <a:xfrm>
            <a:off x="2814150" y="4910961"/>
            <a:ext cx="6605751" cy="3361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Figure S3 </a:t>
            </a:r>
            <a:r>
              <a:rPr lang="en-US" sz="12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KEGG pathways associated with </a:t>
            </a:r>
            <a:r>
              <a:rPr lang="en-US" sz="12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transcripts containing polymorphic SNPs for SB resistance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25704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4</TotalTime>
  <Words>76</Words>
  <Application>Microsoft Office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vi Ranjan Saxesena</dc:creator>
  <cp:lastModifiedBy>Ravi Ranjan Saxesena</cp:lastModifiedBy>
  <cp:revision>49</cp:revision>
  <dcterms:created xsi:type="dcterms:W3CDTF">2021-12-12T06:33:52Z</dcterms:created>
  <dcterms:modified xsi:type="dcterms:W3CDTF">2022-02-13T18:40:26Z</dcterms:modified>
</cp:coreProperties>
</file>